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1" r:id="rId2"/>
    <p:sldId id="272" r:id="rId3"/>
    <p:sldId id="274" r:id="rId4"/>
    <p:sldId id="275" r:id="rId5"/>
    <p:sldId id="27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4201C"/>
    <a:srgbClr val="FF7F03"/>
    <a:srgbClr val="A1CBE1"/>
    <a:srgbClr val="498EC0"/>
    <a:srgbClr val="4CAF4A"/>
    <a:srgbClr val="377EB8"/>
    <a:srgbClr val="535B68"/>
    <a:srgbClr val="E3201D"/>
    <a:srgbClr val="B2DF8A"/>
    <a:srgbClr val="FDBF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863"/>
    <p:restoredTop sz="94153" autoAdjust="0"/>
  </p:normalViewPr>
  <p:slideViewPr>
    <p:cSldViewPr snapToGrid="0">
      <p:cViewPr varScale="1">
        <p:scale>
          <a:sx n="86" d="100"/>
          <a:sy n="86" d="100"/>
        </p:scale>
        <p:origin x="28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B27BA7-1941-8C4D-807F-9C3B4688F3D8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446C04-1B17-474C-866A-BA033E8CDBD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140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baseline="0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446C04-1B17-474C-866A-BA033E8CDB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968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446C04-1B17-474C-866A-BA033E8CDBD2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6969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446C04-1B17-474C-866A-BA033E8CDBD2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026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96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745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1176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0149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850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9992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3192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263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462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2291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2169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F3D3C-DE6D-6746-AEB5-8D4ECBBDB327}" type="datetimeFigureOut">
              <a:rPr lang="en-GB" smtClean="0"/>
              <a:t>04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6E6DA8-023D-EB42-9CB1-50208CB8F33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34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11" Type="http://schemas.openxmlformats.org/officeDocument/2006/relationships/image" Target="../media/image15.jpeg"/><Relationship Id="rId5" Type="http://schemas.openxmlformats.org/officeDocument/2006/relationships/image" Target="../media/image9.jpeg"/><Relationship Id="rId10" Type="http://schemas.openxmlformats.org/officeDocument/2006/relationships/image" Target="../media/image14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>
            <a:extLst>
              <a:ext uri="{FF2B5EF4-FFF2-40B4-BE49-F238E27FC236}">
                <a16:creationId xmlns:a16="http://schemas.microsoft.com/office/drawing/2014/main" id="{EA2F968D-83AB-AB3E-9C38-ECD76DC91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246" y="190835"/>
            <a:ext cx="28866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 dirty="0"/>
              <a:t>Supplementary Figure S1</a:t>
            </a:r>
          </a:p>
        </p:txBody>
      </p:sp>
      <p:sp>
        <p:nvSpPr>
          <p:cNvPr id="10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077" y="744272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A. </a:t>
            </a:r>
            <a:endParaRPr lang="en-US" altLang="en-US" sz="1200" b="1" dirty="0"/>
          </a:p>
        </p:txBody>
      </p:sp>
      <p:sp>
        <p:nvSpPr>
          <p:cNvPr id="11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246" y="5722892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B. </a:t>
            </a:r>
            <a:endParaRPr lang="en-US" altLang="en-US" sz="1200" b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857" y="898160"/>
            <a:ext cx="5397693" cy="4729358"/>
          </a:xfrm>
          <a:prstGeom prst="rect">
            <a:avLst/>
          </a:prstGeom>
        </p:spPr>
      </p:pic>
      <p:pic>
        <p:nvPicPr>
          <p:cNvPr id="8" name="Image 7" descr="C:\Users\C_ASTIER\Desktop\230130_Cholangio\Liquid Versus Tissu\Chromatin Remodeling vs Others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2056" y="6187823"/>
            <a:ext cx="2653610" cy="3250044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 8" descr="C:\Users\C_ASTIER\Desktop\230130_Cholangio\Liquid Versus Tissu\GenomeInte vs Others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3857" y="6187823"/>
            <a:ext cx="2435479" cy="325004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652533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">
            <a:extLst>
              <a:ext uri="{FF2B5EF4-FFF2-40B4-BE49-F238E27FC236}">
                <a16:creationId xmlns:a16="http://schemas.microsoft.com/office/drawing/2014/main" id="{EA2F968D-83AB-AB3E-9C38-ECD76DC91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270" y="176124"/>
            <a:ext cx="28866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 dirty="0"/>
              <a:t>Supplementary Figure S2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0052" y="5719098"/>
            <a:ext cx="3382931" cy="3929458"/>
          </a:xfrm>
          <a:prstGeom prst="rect">
            <a:avLst/>
          </a:prstGeom>
        </p:spPr>
      </p:pic>
      <p:sp>
        <p:nvSpPr>
          <p:cNvPr id="28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077" y="744272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A. </a:t>
            </a:r>
            <a:endParaRPr lang="en-US" altLang="en-US" sz="1200" b="1" dirty="0"/>
          </a:p>
        </p:txBody>
      </p:sp>
      <p:sp>
        <p:nvSpPr>
          <p:cNvPr id="29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077" y="5411321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B. </a:t>
            </a:r>
            <a:endParaRPr lang="en-US" altLang="en-US" sz="1200" b="1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604" y="1159251"/>
            <a:ext cx="4639826" cy="3915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6464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>
            <a:extLst>
              <a:ext uri="{FF2B5EF4-FFF2-40B4-BE49-F238E27FC236}">
                <a16:creationId xmlns:a16="http://schemas.microsoft.com/office/drawing/2014/main" id="{EA2F968D-83AB-AB3E-9C38-ECD76DC91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130" y="138601"/>
            <a:ext cx="28866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 dirty="0"/>
              <a:t>Supplementary Figure S3</a:t>
            </a:r>
          </a:p>
        </p:txBody>
      </p:sp>
      <p:sp>
        <p:nvSpPr>
          <p:cNvPr id="20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53" y="717735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A. </a:t>
            </a:r>
            <a:endParaRPr lang="en-US" altLang="en-US" sz="1200" b="1" dirty="0"/>
          </a:p>
        </p:txBody>
      </p:sp>
      <p:pic>
        <p:nvPicPr>
          <p:cNvPr id="17" name="Image 16" descr="C:\Users\C_ASTIER\Desktop\230130_Cholangio\Liquid Versus Tissu\ctDNA versus sous-type_Avec MSI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872" y="1025511"/>
            <a:ext cx="1990924" cy="2540461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Image 23" descr="C:\Users\C_ASTIER\Desktop\230130_Cholangio\Liquid Versus Tissu\ctDNA versus SEX.jp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840" y="4236236"/>
            <a:ext cx="2229649" cy="2778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Image 24" descr="C:\Users\C_ASTIER\Desktop\230130_Cholangio\Liquid Versus Tissu\ctDNA vs stage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88" y="7159136"/>
            <a:ext cx="2181723" cy="2549855"/>
          </a:xfrm>
          <a:prstGeom prst="rect">
            <a:avLst/>
          </a:prstGeom>
          <a:noFill/>
          <a:ln>
            <a:noFill/>
          </a:ln>
        </p:spPr>
      </p:pic>
      <p:sp>
        <p:nvSpPr>
          <p:cNvPr id="26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93" y="3925124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C. </a:t>
            </a:r>
            <a:endParaRPr lang="en-US" altLang="en-US" sz="1200" b="1" dirty="0"/>
          </a:p>
        </p:txBody>
      </p:sp>
      <p:pic>
        <p:nvPicPr>
          <p:cNvPr id="28" name="Image 27" descr="C:\Users\C_ASTIER\Desktop\230130_Cholangio\Liquid Versus Tissu\ctDNA vs AGE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1322" y="4165440"/>
            <a:ext cx="2352158" cy="2829223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Image 28" descr="C:\Users\C_ASTIER\Desktop\230130_Cholangio\Liquid Versus Tissu\ctDNA vs differentiation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8200" y="4261854"/>
            <a:ext cx="2227947" cy="2603806"/>
          </a:xfrm>
          <a:prstGeom prst="rect">
            <a:avLst/>
          </a:prstGeom>
          <a:noFill/>
          <a:ln>
            <a:noFill/>
          </a:ln>
        </p:spPr>
      </p:pic>
      <p:sp>
        <p:nvSpPr>
          <p:cNvPr id="30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0261" y="3925124"/>
            <a:ext cx="4042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E. </a:t>
            </a:r>
            <a:endParaRPr lang="en-US" altLang="en-US" sz="1200" b="1" dirty="0"/>
          </a:p>
        </p:txBody>
      </p:sp>
      <p:sp>
        <p:nvSpPr>
          <p:cNvPr id="31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88" y="7024108"/>
            <a:ext cx="37317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F. </a:t>
            </a:r>
            <a:endParaRPr lang="en-US" altLang="en-US" sz="1200" b="1" dirty="0"/>
          </a:p>
        </p:txBody>
      </p:sp>
      <p:pic>
        <p:nvPicPr>
          <p:cNvPr id="32" name="Image 31" descr="C:\Users\C_ASTIER\Desktop\230130_Cholangio\Liquid Versus Tissu\ctDNA vs nbr lines total.jp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4489" y="7234979"/>
            <a:ext cx="2147334" cy="2474012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4489" y="7024108"/>
            <a:ext cx="42351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G. </a:t>
            </a:r>
            <a:endParaRPr lang="en-US" altLang="en-US" sz="1200" b="1" dirty="0"/>
          </a:p>
        </p:txBody>
      </p:sp>
      <p:sp>
        <p:nvSpPr>
          <p:cNvPr id="27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8036" y="3925124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D. </a:t>
            </a:r>
            <a:endParaRPr lang="en-US" altLang="en-US" sz="1200" b="1" dirty="0"/>
          </a:p>
        </p:txBody>
      </p:sp>
      <p:pic>
        <p:nvPicPr>
          <p:cNvPr id="16" name="Image 15" descr="C:\Users\C_ASTIER\Desktop\230130_Cholangio\Liquid Versus Tissu\ctDNA versus sous-type_sans MSI.jpg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8302" y="1024999"/>
            <a:ext cx="2075891" cy="2582638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Image 22" descr="C:\Users\C_ASTIER\Desktop\230130_Cholangio\Liquid Versus Tissu\Metastatic burden vs ctDNA alterations_AVEC MSI.jpg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1531" y="810735"/>
            <a:ext cx="1945002" cy="2762291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1893" y="745178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B. </a:t>
            </a:r>
            <a:endParaRPr lang="en-US" altLang="en-US" sz="1200" b="1" dirty="0"/>
          </a:p>
        </p:txBody>
      </p:sp>
      <p:pic>
        <p:nvPicPr>
          <p:cNvPr id="22" name="Image 21" descr="C:\Users\C_ASTIER\Desktop\230130_Cholangio\Liquid Versus Tissu\Metastatic burden vs ctDNA alterations_sans MSI.jpg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2216" y="911146"/>
            <a:ext cx="1912364" cy="2683779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20" descr="C:\Users\C_ASTIER\Desktop\230130_Cholangio\Liquid Versus Tissu\Surgery vs biopsy tumor DNA_sans MSI.jpg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2351" y="7331886"/>
            <a:ext cx="1952285" cy="2399660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7247" y="7009386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H</a:t>
            </a:r>
            <a:r>
              <a:rPr lang="en-US" altLang="en-US" sz="1400" b="1" dirty="0" smtClean="0"/>
              <a:t>. 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37227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2">
            <a:extLst>
              <a:ext uri="{FF2B5EF4-FFF2-40B4-BE49-F238E27FC236}">
                <a16:creationId xmlns:a16="http://schemas.microsoft.com/office/drawing/2014/main" id="{EA2F968D-83AB-AB3E-9C38-ECD76DC91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130" y="138601"/>
            <a:ext cx="28866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 dirty="0"/>
              <a:t>Supplementary Figure S4</a:t>
            </a:r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9506" y="5203080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B. </a:t>
            </a:r>
            <a:endParaRPr lang="en-US" altLang="en-US" sz="1200" b="1" dirty="0"/>
          </a:p>
        </p:txBody>
      </p:sp>
      <p:sp>
        <p:nvSpPr>
          <p:cNvPr id="18" name="TextBox 3">
            <a:extLst>
              <a:ext uri="{FF2B5EF4-FFF2-40B4-BE49-F238E27FC236}">
                <a16:creationId xmlns:a16="http://schemas.microsoft.com/office/drawing/2014/main" id="{4B54BDB1-7D24-C14C-9B24-4949E48563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9506" y="1022941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A. </a:t>
            </a:r>
            <a:endParaRPr lang="en-US" altLang="en-US" sz="1200" b="1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826" y="1388373"/>
            <a:ext cx="4947586" cy="355659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506" y="5856183"/>
            <a:ext cx="4945906" cy="3564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68485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CEFA313C-6E13-6B60-1FD5-E80ABE21C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88" y="4030089"/>
            <a:ext cx="41389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B. </a:t>
            </a:r>
            <a:endParaRPr lang="en-US" altLang="en-US" sz="1200" b="1" dirty="0"/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CEFA313C-6E13-6B60-1FD5-E80ABE21C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35" y="612719"/>
            <a:ext cx="3642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A.</a:t>
            </a:r>
            <a:endParaRPr lang="en-US" altLang="en-US" sz="1200" b="1" dirty="0"/>
          </a:p>
        </p:txBody>
      </p:sp>
      <p:sp>
        <p:nvSpPr>
          <p:cNvPr id="16" name="TextBox 2">
            <a:extLst>
              <a:ext uri="{FF2B5EF4-FFF2-40B4-BE49-F238E27FC236}">
                <a16:creationId xmlns:a16="http://schemas.microsoft.com/office/drawing/2014/main" id="{EA2F968D-83AB-AB3E-9C38-ECD76DC91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195" y="214021"/>
            <a:ext cx="28866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 dirty="0"/>
              <a:t>Supplementary Figure </a:t>
            </a:r>
            <a:r>
              <a:rPr lang="en-US" altLang="en-US" sz="1600" b="1" dirty="0" smtClean="0"/>
              <a:t>S5</a:t>
            </a:r>
            <a:endParaRPr lang="en-US" altLang="en-US" sz="1600" b="1" dirty="0"/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953" y="6277497"/>
            <a:ext cx="3387370" cy="1812395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63937" y="6261707"/>
            <a:ext cx="3480955" cy="18108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417588"/>
            <a:ext cx="3345778" cy="1799765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45778" y="4417705"/>
            <a:ext cx="3490594" cy="1799648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792" y="8876719"/>
            <a:ext cx="6558290" cy="894648"/>
          </a:xfrm>
          <a:prstGeom prst="rect">
            <a:avLst/>
          </a:prstGeom>
        </p:spPr>
      </p:pic>
      <p:graphicFrame>
        <p:nvGraphicFramePr>
          <p:cNvPr id="10" name="Tableau 9">
            <a:extLst>
              <a:ext uri="{FF2B5EF4-FFF2-40B4-BE49-F238E27FC236}">
                <a16:creationId xmlns:a16="http://schemas.microsoft.com/office/drawing/2014/main" id="{A4CC73C6-7B7F-9B57-B214-B765A3B4BF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5311971"/>
              </p:ext>
            </p:extLst>
          </p:nvPr>
        </p:nvGraphicFramePr>
        <p:xfrm>
          <a:off x="233636" y="940074"/>
          <a:ext cx="4251205" cy="1830458"/>
        </p:xfrm>
        <a:graphic>
          <a:graphicData uri="http://schemas.openxmlformats.org/drawingml/2006/table">
            <a:tbl>
              <a:tblPr/>
              <a:tblGrid>
                <a:gridCol w="387112">
                  <a:extLst>
                    <a:ext uri="{9D8B030D-6E8A-4147-A177-3AD203B41FA5}">
                      <a16:colId xmlns:a16="http://schemas.microsoft.com/office/drawing/2014/main" val="310319659"/>
                    </a:ext>
                  </a:extLst>
                </a:gridCol>
                <a:gridCol w="619919">
                  <a:extLst>
                    <a:ext uri="{9D8B030D-6E8A-4147-A177-3AD203B41FA5}">
                      <a16:colId xmlns:a16="http://schemas.microsoft.com/office/drawing/2014/main" val="2988737343"/>
                    </a:ext>
                  </a:extLst>
                </a:gridCol>
                <a:gridCol w="578712">
                  <a:extLst>
                    <a:ext uri="{9D8B030D-6E8A-4147-A177-3AD203B41FA5}">
                      <a16:colId xmlns:a16="http://schemas.microsoft.com/office/drawing/2014/main" val="817118112"/>
                    </a:ext>
                  </a:extLst>
                </a:gridCol>
                <a:gridCol w="543520">
                  <a:extLst>
                    <a:ext uri="{9D8B030D-6E8A-4147-A177-3AD203B41FA5}">
                      <a16:colId xmlns:a16="http://schemas.microsoft.com/office/drawing/2014/main" val="854226114"/>
                    </a:ext>
                  </a:extLst>
                </a:gridCol>
                <a:gridCol w="599566">
                  <a:extLst>
                    <a:ext uri="{9D8B030D-6E8A-4147-A177-3AD203B41FA5}">
                      <a16:colId xmlns:a16="http://schemas.microsoft.com/office/drawing/2014/main" val="1903039444"/>
                    </a:ext>
                  </a:extLst>
                </a:gridCol>
                <a:gridCol w="375381">
                  <a:extLst>
                    <a:ext uri="{9D8B030D-6E8A-4147-A177-3AD203B41FA5}">
                      <a16:colId xmlns:a16="http://schemas.microsoft.com/office/drawing/2014/main" val="2772740324"/>
                    </a:ext>
                  </a:extLst>
                </a:gridCol>
                <a:gridCol w="552643">
                  <a:extLst>
                    <a:ext uri="{9D8B030D-6E8A-4147-A177-3AD203B41FA5}">
                      <a16:colId xmlns:a16="http://schemas.microsoft.com/office/drawing/2014/main" val="1192617194"/>
                    </a:ext>
                  </a:extLst>
                </a:gridCol>
                <a:gridCol w="594352">
                  <a:extLst>
                    <a:ext uri="{9D8B030D-6E8A-4147-A177-3AD203B41FA5}">
                      <a16:colId xmlns:a16="http://schemas.microsoft.com/office/drawing/2014/main" val="2509028006"/>
                    </a:ext>
                  </a:extLst>
                </a:gridCol>
              </a:tblGrid>
              <a:tr h="93802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ugo_Symbol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t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_Allele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mor_Seq_Allele2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t_Classification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t_Type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NOVAR classification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pression (IHC)</a:t>
                      </a:r>
                    </a:p>
                  </a:txBody>
                  <a:tcPr marL="4138" marR="4138" marT="41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7394238"/>
                  </a:ext>
                </a:extLst>
              </a:tr>
              <a:tr h="88284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ID1A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213fs*19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5628071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1780fs*4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1495160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590fs*29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371468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2012_L2016del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AAGCTGATCCTG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_Frame_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3915894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865fs*7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3464704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464fs*155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2566927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2037*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sense_Mutation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955465"/>
                  </a:ext>
                </a:extLst>
              </a:tr>
              <a:tr h="9380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2159*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sense_Mutation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2092588"/>
                  </a:ext>
                </a:extLst>
              </a:tr>
              <a:tr h="88284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RM1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 site 529-1G&gt;A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_Sit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98006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279fs*8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 (mosaic)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391260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922*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sense_Mutation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6187901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1020fs*1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 (mosaic)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0624498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434*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sense_Mutation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Pathogenic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0011991"/>
                  </a:ext>
                </a:extLst>
              </a:tr>
              <a:tr h="9380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141fs*10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act 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5955492"/>
                  </a:ext>
                </a:extLst>
              </a:tr>
              <a:tr h="88284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6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P1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 site 1984-24_1989del30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lice_Sit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reased</a:t>
                      </a:r>
                      <a:r>
                        <a:rPr lang="en-GB" sz="500" b="0" i="0" u="none" strike="noStrike" baseline="0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xpression</a:t>
                      </a:r>
                      <a:endParaRPr lang="en-GB" sz="500" b="0" i="0" u="none" strike="noStrike" noProof="1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6136261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605fs*36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E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1292328"/>
                  </a:ext>
                </a:extLst>
              </a:tr>
              <a:tr h="882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R264fs*20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_Shift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1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reased expression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8472043"/>
                  </a:ext>
                </a:extLst>
              </a:tr>
              <a:tr h="9380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452_K453insF</a:t>
                      </a:r>
                    </a:p>
                  </a:txBody>
                  <a:tcPr marL="4138" marR="4138" marT="41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_Frame_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act</a:t>
                      </a:r>
                    </a:p>
                  </a:txBody>
                  <a:tcPr marL="4138" marR="4138" marT="413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4110977"/>
                  </a:ext>
                </a:extLst>
              </a:tr>
            </a:tbl>
          </a:graphicData>
        </a:graphic>
      </p:graphicFrame>
      <p:pic>
        <p:nvPicPr>
          <p:cNvPr id="11" name="Imag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26600" y="3086542"/>
            <a:ext cx="4316482" cy="943547"/>
          </a:xfrm>
          <a:prstGeom prst="rect">
            <a:avLst/>
          </a:prstGeom>
        </p:spPr>
      </p:pic>
      <p:sp>
        <p:nvSpPr>
          <p:cNvPr id="12" name="TextBox 3">
            <a:extLst>
              <a:ext uri="{FF2B5EF4-FFF2-40B4-BE49-F238E27FC236}">
                <a16:creationId xmlns:a16="http://schemas.microsoft.com/office/drawing/2014/main" id="{CEFA313C-6E13-6B60-1FD5-E80ABE21C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82" y="8329417"/>
            <a:ext cx="36420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/>
              <a:t>C.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5699742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86</TotalTime>
  <Words>215</Words>
  <Application>Microsoft Office PowerPoint</Application>
  <PresentationFormat>Format A4 (210 x 297 mm)</PresentationFormat>
  <Paragraphs>162</Paragraphs>
  <Slides>5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lemence astier</dc:creator>
  <cp:lastModifiedBy>ASTIER Clemence</cp:lastModifiedBy>
  <cp:revision>255</cp:revision>
  <dcterms:created xsi:type="dcterms:W3CDTF">2022-08-12T16:44:53Z</dcterms:created>
  <dcterms:modified xsi:type="dcterms:W3CDTF">2024-01-04T14:47:10Z</dcterms:modified>
</cp:coreProperties>
</file>